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737DAF-3B95-4E9F-9110-0812AA6ACE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83858AD-0A80-492A-928D-74C6DC9D81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EDEF4C-F97D-4A79-9AEB-62362C44A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892D13-EAD1-44BC-A054-F4D974366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F9E0CB-4D23-4C80-980D-B5E844F2F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004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BBEB6A-12B4-4F3F-BAB0-4AE8808083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D929CC-13A2-450F-AEB9-51ACC6A696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F4E916-8CFD-43D2-8B5E-64BCEBB57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C4619A-EE23-49A3-91B5-3942D6ACB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B45227-F773-40AB-9C92-52CA0F209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409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A35246-F0F7-4995-BAEC-EDD4745C18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DA8FB0D-5C9B-43A7-826D-164CC2B8CB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55B542-6408-4E27-A34B-4536BDF62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346BAD-402B-4345-B760-2D83C46B8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E74B50-A338-41D6-94AA-E2A48FF7D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18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70B3ED-8964-4D9F-A08D-AFD205BFD7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C46691-4937-45CF-B10A-D6692C7E71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10B8A9-093E-42D0-9D3B-5F776DFD6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BFD1D7-9BB2-4FAB-AF3F-798AF27AB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B0F8F0-9196-4561-BEAE-085141EE0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167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F6AA52-9975-4A83-A436-272F63E75E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740DE4-1296-4B9F-A950-199B5343E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D626AE-F17C-41B3-9F56-6915A8F95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21C9C5-A774-4201-BC32-D42C50FCF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FEFAB2-1C64-4108-8B6D-102D48AE0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3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017E67-DCBA-4F80-B1DD-007E0FE7CA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D33BC0-34DD-4DE2-879F-376FEFD26A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8B75BA-EB9D-4674-AEE5-E5373AED36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7B05300-9346-4017-8DBD-2DD6FA252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E9F94E-6CF2-4B5D-BD3B-01C3193F1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69DB3C-0482-4FFA-838F-CE75DC5EE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493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27B4F4-46D6-46C6-A725-AB30E030C1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2E05D8-249A-4D52-BD7A-5D81292106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D3475E5-C51E-4C89-9773-EC62258AFA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6B29B6-E79E-4852-A362-64C039E79B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B762370-E9A5-4E04-898A-9BAD9DC5AD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3077D9D-50FE-4347-9914-4B05A854D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1827D9-1395-45A9-90E5-57102528B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6940BEC-B1D6-4B32-BA48-0E573A6B7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064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9FCCA1-36E1-4B91-A05F-00ADAF2307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01D4434-78DB-469F-9D59-FFB3DC64B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8B76033-9DA2-4289-BB45-760F0E6D4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3972C33-EFC7-45AF-8057-44A420996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863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71F1062-A8A6-42BE-9584-7DF9648C3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A49BFFB-4E7D-400C-93EC-EFD79B5DE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CAAD91B-2E1C-4FE7-9715-AEA1C9C4F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050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899DE9-1882-4993-BAFF-A17CB381F2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432752-1352-4E54-80EB-01C704FF46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C172D3-A91F-49E4-831F-182D717F45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743570-DABC-43F7-A2DC-F2492DF76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E2E685-BA73-44F9-9E97-E129B4970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33394D-7AED-4957-B0AE-E03B97ECC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447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C46873-F9C9-47C4-BA31-D2EF8E82B5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CAA8310-0F80-4554-AF44-29568488A6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61F12D-B730-42AD-AE65-1B02F0AD5D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49621A9-66B8-49C3-99CB-CE373DA93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F3EB47-5D7C-49B6-9655-A095DA123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F3D4C2-FB39-49D2-B453-224A119F8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913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3F512AB-5D45-4ADE-886A-6E9AE5DD8F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FAC0D4B-D77C-4B3E-ABA2-9856420185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764059-D3AA-4547-AC49-E7C9291ED7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E2A21-4D86-4C60-B117-A437F5A0D733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3EABA4-4CDE-465D-9674-4091AEE8F3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BB0FD4-94EA-4B51-9C40-DE73252F73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215D09-4ECF-4D73-9581-A34D69E6E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285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BCF389-45E2-4AAB-887D-2979BD888C2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MTS 20190405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C7C48D2-2C67-4FE5-8B73-9CF227350AF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67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C38458-51E7-4605-B07A-547C9D8D5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tandard Curve</a:t>
            </a:r>
          </a:p>
        </p:txBody>
      </p:sp>
      <p:pic>
        <p:nvPicPr>
          <p:cNvPr id="7" name="内容占位符 6">
            <a:extLst>
              <a:ext uri="{FF2B5EF4-FFF2-40B4-BE49-F238E27FC236}">
                <a16:creationId xmlns:a16="http://schemas.microsoft.com/office/drawing/2014/main" id="{1E51F99D-C6B0-477E-8C92-AA5F362B900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453326" y="1798320"/>
            <a:ext cx="7285348" cy="4378960"/>
          </a:xfrm>
          <a:prstGeom prst="rect">
            <a:avLst/>
          </a:prstGeom>
        </p:spPr>
      </p:pic>
      <p:sp>
        <p:nvSpPr>
          <p:cNvPr id="3" name="椭圆 2">
            <a:extLst>
              <a:ext uri="{FF2B5EF4-FFF2-40B4-BE49-F238E27FC236}">
                <a16:creationId xmlns:a16="http://schemas.microsoft.com/office/drawing/2014/main" id="{F9DF24EB-CBB8-4F68-B4DC-68F655A0E646}"/>
              </a:ext>
            </a:extLst>
          </p:cNvPr>
          <p:cNvSpPr/>
          <p:nvPr/>
        </p:nvSpPr>
        <p:spPr>
          <a:xfrm>
            <a:off x="4348480" y="5384800"/>
            <a:ext cx="680720" cy="28448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椭圆 4">
            <a:extLst>
              <a:ext uri="{FF2B5EF4-FFF2-40B4-BE49-F238E27FC236}">
                <a16:creationId xmlns:a16="http://schemas.microsoft.com/office/drawing/2014/main" id="{3D92F6D8-266E-406C-B128-0853784E5681}"/>
              </a:ext>
            </a:extLst>
          </p:cNvPr>
          <p:cNvSpPr/>
          <p:nvPr/>
        </p:nvSpPr>
        <p:spPr>
          <a:xfrm>
            <a:off x="7032352" y="5384800"/>
            <a:ext cx="680720" cy="28448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6184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animBg="1"/>
      <p:bldP spid="5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DBC4EB-0D6C-41E7-8391-A1BB8846B3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pPr algn="ctr"/>
            <a:r>
              <a:rPr lang="en-US"/>
              <a:t>Microplate Reader</a:t>
            </a:r>
            <a:endParaRPr lang="en-US" dirty="0"/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14F866-1078-47BF-9E73-F5AF570E5A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A4594EC3-D6AC-48F1-B86A-195EF6BCFF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6092206"/>
              </p:ext>
            </p:extLst>
          </p:nvPr>
        </p:nvGraphicFramePr>
        <p:xfrm>
          <a:off x="1858645" y="2682081"/>
          <a:ext cx="8115677" cy="1493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Worksheet" r:id="rId3" imgW="8210464" imgH="1511125" progId="Excel.Sheet.12">
                  <p:embed/>
                </p:oleObj>
              </mc:Choice>
              <mc:Fallback>
                <p:oleObj name="Worksheet" r:id="rId3" imgW="8210464" imgH="151112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58645" y="2682081"/>
                        <a:ext cx="8115677" cy="1493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22B7BB5-31BD-4EF6-B9A6-B02314447781}"/>
              </a:ext>
            </a:extLst>
          </p:cNvPr>
          <p:cNvCxnSpPr/>
          <p:nvPr/>
        </p:nvCxnSpPr>
        <p:spPr>
          <a:xfrm>
            <a:off x="3647440" y="2316480"/>
            <a:ext cx="0" cy="36560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15F7CB1-F6FF-4A8E-A544-1D13B98A5160}"/>
              </a:ext>
            </a:extLst>
          </p:cNvPr>
          <p:cNvCxnSpPr/>
          <p:nvPr/>
        </p:nvCxnSpPr>
        <p:spPr>
          <a:xfrm>
            <a:off x="7284720" y="2316480"/>
            <a:ext cx="0" cy="36560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692922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内容占位符 9">
            <a:extLst>
              <a:ext uri="{FF2B5EF4-FFF2-40B4-BE49-F238E27FC236}">
                <a16:creationId xmlns:a16="http://schemas.microsoft.com/office/drawing/2014/main" id="{3FD695DB-1F8F-461A-8A15-91C8899105F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677281" y="1097280"/>
            <a:ext cx="7481959" cy="4868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199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32BC26D8-82FB-445E-AA49-62A77D7C1EE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B44330D-EA18-4254-AA95-EB49948539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D2BE20C-B950-4180-8EB5-C84626F3A003}"/>
              </a:ext>
            </a:extLst>
          </p:cNvPr>
          <p:cNvSpPr txBox="1"/>
          <p:nvPr/>
        </p:nvSpPr>
        <p:spPr>
          <a:xfrm>
            <a:off x="1026160" y="945455"/>
            <a:ext cx="5943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l Viability=(OD</a:t>
            </a:r>
            <a:r>
              <a:rPr lang="en-US" altLang="zh-CN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D</a:t>
            </a:r>
            <a:r>
              <a:rPr lang="en-US" altLang="zh-CN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/(OD</a:t>
            </a:r>
            <a:r>
              <a:rPr lang="en-US" altLang="zh-CN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D</a:t>
            </a:r>
            <a:r>
              <a:rPr lang="en-US" altLang="zh-CN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×100%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FCF4949-CCBF-483E-AA0B-771AF3BA2AE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26003" y="1825625"/>
            <a:ext cx="713999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228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5</Words>
  <Application>Microsoft Office PowerPoint</Application>
  <PresentationFormat>宽屏</PresentationFormat>
  <Paragraphs>4</Paragraphs>
  <Slides>5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主题​​</vt:lpstr>
      <vt:lpstr>Worksheet</vt:lpstr>
      <vt:lpstr>MTS 20190405</vt:lpstr>
      <vt:lpstr>Standard Curve</vt:lpstr>
      <vt:lpstr>Microplate Reader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 weifeng</dc:creator>
  <cp:lastModifiedBy>lu weifeng</cp:lastModifiedBy>
  <cp:revision>8</cp:revision>
  <dcterms:created xsi:type="dcterms:W3CDTF">2019-04-08T05:08:10Z</dcterms:created>
  <dcterms:modified xsi:type="dcterms:W3CDTF">2019-04-08T20:05:53Z</dcterms:modified>
</cp:coreProperties>
</file>